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9"/>
  </p:notesMasterIdLst>
  <p:sldIdLst>
    <p:sldId id="456" r:id="rId3"/>
    <p:sldId id="467" r:id="rId4"/>
    <p:sldId id="266" r:id="rId5"/>
    <p:sldId id="466" r:id="rId6"/>
    <p:sldId id="461" r:id="rId7"/>
    <p:sldId id="455" r:id="rId8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86053" autoAdjust="0"/>
  </p:normalViewPr>
  <p:slideViewPr>
    <p:cSldViewPr snapToGrid="0">
      <p:cViewPr varScale="1">
        <p:scale>
          <a:sx n="98" d="100"/>
          <a:sy n="98" d="100"/>
        </p:scale>
        <p:origin x="10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ABFC693-3D98-44B0-8821-E091FB17B6E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751DF6A-D91B-47D5-9D92-AD7F8F065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813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B78A51-36F8-45FD-97FD-FE7D2AB569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3FFD90E-9F2E-44FD-A476-1CC0AA28B4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407665-56A5-4EF9-A00A-F5BFFA70A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7E0CFE-B363-4D65-B6E6-AAF56C3F9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F666DF-4CC1-4D9C-B499-665529A9C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825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3E095-6CFF-40CF-AEC5-E98E1121DC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B81C54-C498-4A32-BB10-398EDFEB2C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079585-B883-4B44-901D-801F181D11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F312F2-2368-4A76-A7F8-787E7B195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D56FAD-B4CB-44F5-827B-ABDC1A620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178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CE2AAB-C6E8-4491-8C00-A240DEF2AE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437BC1-D49F-4FC6-9E87-ADABA2DA8B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3613E7-A595-4E17-BEC2-7D8744E5D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140CBE-1EC7-4940-911A-B160CEB1D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DBBC37-2C71-4381-94DB-65143703F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11683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4"/>
            <a:ext cx="10363200" cy="2387600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95133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48377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5"/>
            <a:ext cx="10515600" cy="150018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18407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95489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20748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49611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19950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909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22608-E378-4DD8-9D17-E033569144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29D18C-AFFB-4859-8B07-CF980649C9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B65F79-C267-48AC-8587-C72BB78BD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04E1FF-215A-4EBA-9764-6AA4F056F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642970-1AF0-4A2D-8E07-96C7ECA6B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8127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58125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76045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901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959335-7E25-4B3F-9A94-4A5AC9E83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F52EF2-1C00-4021-B433-BCB40889C4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928EBC-F4DC-4A1A-83D5-1818B9909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E1C823-B51D-456F-95DA-9217D50F3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0ADBDC-568C-4617-B9F2-33E28AE1E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819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C23DD4-51FE-44E2-A693-82EB9F856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5561AA-42BA-4D95-8569-35F031F669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49A7FA-EDF6-4A9E-9327-78D21100CD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B9195B-A6CC-47DF-83C3-2B0AB3C58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0A462C-344B-486B-8E35-F2A63E8BB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B5DF6B-9F9A-49CD-ADE7-72399AE09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961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657B9-8020-4823-96AD-0E261D1399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A70A13-C469-4742-AA53-2060A31D9A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1D2493-3C3B-40DE-B8F1-6AEFA0593E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91CEC6-A3BF-48E4-B72B-B1C4C82B8D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741740-49E6-453A-84B3-6B0B8C4D5A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8E982B-8925-45DD-8953-44EB07F4E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AAE350-A080-4EE0-924D-5D864185A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7686C2-768F-4F00-8404-FB9AD883B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893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980F0E-4AAC-43B2-90B4-4E237E9384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55DC95F-91FC-40D3-9957-7612DCF77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5BC5C3-4BDA-4D46-8F0C-9C5EBB2CF9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3DD279-7944-4E14-9BE3-0875B7C97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628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6F336B-B289-4BB6-A0AC-9389541FD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784EE0-201E-494C-92BC-14CF866D6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C11F8F-FEEC-40E0-A245-EB1FFFBAE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633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9245A-CFFB-47CC-A457-F6F36C7D8E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CD87A7-933F-4058-9AC3-7D54C1C5E3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B1B6F8-3D01-44C7-AECC-75D90869CA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631856-E8E2-44C4-AD8B-12F475C84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6883DC-CF1C-4B11-9402-3E58086DF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531E07-8D47-4498-969A-B11EA18FA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802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8D90B-51DB-4717-BC28-5D8A0CDE0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C10732-D01D-4E24-ABB1-2CFD3B299F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FB8AE6-475A-49D4-BA01-096946C94E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241E1D-F6DB-4C2A-A256-27FDC10EE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F51483-8917-4154-BB80-52D8BCE3E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2DC341-AC58-4A52-B8F7-19AF999E1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179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36690B-F7F5-4AE8-A4C6-A61DAE438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6DCE2-8101-4668-804B-F23237AA33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0A31CD-5852-4F05-A885-F837D09D30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AABC59-EEDE-4593-8461-8D6734DF5DD5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9FBC40-AFEA-49AA-B73C-A643CCCD35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4F6DDC-8ED6-456A-A079-9EC603527C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701BB-503D-4AF8-8823-EA804EE29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987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365288-714F-4756-B01F-E9F5D674F23D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67E16-4CAD-4974-8191-2D666AB88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403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27079-344E-4CAB-9D84-1EAB137F49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175649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2800" dirty="0">
                <a:latin typeface="+mn-lt"/>
              </a:rPr>
              <a:t>Supplementary Materia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DFA834D-D2DF-6655-DA98-3248BBEC8F95}"/>
              </a:ext>
            </a:extLst>
          </p:cNvPr>
          <p:cNvSpPr txBox="1"/>
          <p:nvPr/>
        </p:nvSpPr>
        <p:spPr>
          <a:xfrm>
            <a:off x="791183" y="1260908"/>
            <a:ext cx="1140081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HLA-DPB1 genotype variants predict DP molecule cell surface expression and DP donor specific antibody binding capacity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39179281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DE39E63-6E20-6E35-AEC6-14A09AB02B67}"/>
              </a:ext>
            </a:extLst>
          </p:cNvPr>
          <p:cNvSpPr txBox="1"/>
          <p:nvPr/>
        </p:nvSpPr>
        <p:spPr>
          <a:xfrm>
            <a:off x="459702" y="224325"/>
            <a:ext cx="106492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latin typeface="+mn-lt"/>
                <a:ea typeface="+mn-ea"/>
                <a:cs typeface="+mn-cs"/>
              </a:rPr>
              <a:t>Supplemental figure 1. Flow chart illustrating the experimental procedures conducted on diverse cell types</a:t>
            </a:r>
            <a:endParaRPr lang="en-US" dirty="0"/>
          </a:p>
        </p:txBody>
      </p:sp>
      <p:pic>
        <p:nvPicPr>
          <p:cNvPr id="3" name="Picture 2" descr="A diagram of a cell division&#10;&#10;Description automatically generated with medium confidence">
            <a:extLst>
              <a:ext uri="{FF2B5EF4-FFF2-40B4-BE49-F238E27FC236}">
                <a16:creationId xmlns:a16="http://schemas.microsoft.com/office/drawing/2014/main" id="{4AF3AB77-3646-633B-C833-9ADE2BA43C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3876" y="817418"/>
            <a:ext cx="9044247" cy="5223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3044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4" name="Rectangle 23">
            <a:extLst>
              <a:ext uri="{FF2B5EF4-FFF2-40B4-BE49-F238E27FC236}">
                <a16:creationId xmlns:a16="http://schemas.microsoft.com/office/drawing/2014/main" id="{99ED5833-B85B-4103-8A3B-CAB0308E6C1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DFCD447-847F-482C-8B1D-B0BB614D571F}"/>
              </a:ext>
            </a:extLst>
          </p:cNvPr>
          <p:cNvSpPr txBox="1"/>
          <p:nvPr/>
        </p:nvSpPr>
        <p:spPr>
          <a:xfrm>
            <a:off x="-389663" y="-176676"/>
            <a:ext cx="9795638" cy="96960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100" b="1" dirty="0">
                <a:latin typeface="+mj-lt"/>
                <a:ea typeface="+mj-ea"/>
                <a:cs typeface="+mj-cs"/>
              </a:rPr>
              <a:t>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047BF7A-F090-4440-AD2F-26ACC82E3246}"/>
              </a:ext>
            </a:extLst>
          </p:cNvPr>
          <p:cNvSpPr txBox="1"/>
          <p:nvPr/>
        </p:nvSpPr>
        <p:spPr>
          <a:xfrm>
            <a:off x="410111" y="169627"/>
            <a:ext cx="11368725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/>
              <a:t>Supplemental table 1. HLA-DPB1 alleles included in B cells and BLCLs for research experiments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5DCE2DF-C51D-3F06-395E-CC3132E8A4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5722836"/>
              </p:ext>
            </p:extLst>
          </p:nvPr>
        </p:nvGraphicFramePr>
        <p:xfrm>
          <a:off x="3873115" y="969606"/>
          <a:ext cx="4442718" cy="532784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2362027">
                  <a:extLst>
                    <a:ext uri="{9D8B030D-6E8A-4147-A177-3AD203B41FA5}">
                      <a16:colId xmlns:a16="http://schemas.microsoft.com/office/drawing/2014/main" val="3049629100"/>
                    </a:ext>
                  </a:extLst>
                </a:gridCol>
                <a:gridCol w="1006679">
                  <a:extLst>
                    <a:ext uri="{9D8B030D-6E8A-4147-A177-3AD203B41FA5}">
                      <a16:colId xmlns:a16="http://schemas.microsoft.com/office/drawing/2014/main" val="862876327"/>
                    </a:ext>
                  </a:extLst>
                </a:gridCol>
                <a:gridCol w="1074012">
                  <a:extLst>
                    <a:ext uri="{9D8B030D-6E8A-4147-A177-3AD203B41FA5}">
                      <a16:colId xmlns:a16="http://schemas.microsoft.com/office/drawing/2014/main" val="2628285819"/>
                    </a:ext>
                  </a:extLst>
                </a:gridCol>
              </a:tblGrid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HLA-DPB1 allele (rs9277534A 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 cel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LC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3876260493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2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3474665134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2: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075059364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4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421364155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4: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932826053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7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1725221457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3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3431558506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0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16691402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9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1738482941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0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072964456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8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4081225198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05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889055686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HLA-DPB1 allele (rs9277534G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1835054235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1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335283047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3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646493622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5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1446569399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9: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3337026636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0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773740883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1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869449699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: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655157183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3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3490084832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4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791607334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5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3617492791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6: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488200152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8: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3153072674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9: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1116428030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0: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249523255"/>
                  </a:ext>
                </a:extLst>
              </a:tr>
              <a:tr h="1718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8: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00" marR="7400" marT="7400" marB="0" anchor="b"/>
                </a:tc>
                <a:extLst>
                  <a:ext uri="{0D108BD9-81ED-4DB2-BD59-A6C34878D82A}">
                    <a16:rowId xmlns:a16="http://schemas.microsoft.com/office/drawing/2014/main" val="23770341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647661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2ECD81D3-A93A-F1D5-F092-B0B7AB952C4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509771"/>
              </p:ext>
            </p:extLst>
          </p:nvPr>
        </p:nvGraphicFramePr>
        <p:xfrm>
          <a:off x="7123809" y="25167"/>
          <a:ext cx="3424912" cy="7844881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64821">
                  <a:extLst>
                    <a:ext uri="{9D8B030D-6E8A-4147-A177-3AD203B41FA5}">
                      <a16:colId xmlns:a16="http://schemas.microsoft.com/office/drawing/2014/main" val="3814438172"/>
                    </a:ext>
                  </a:extLst>
                </a:gridCol>
                <a:gridCol w="637158">
                  <a:extLst>
                    <a:ext uri="{9D8B030D-6E8A-4147-A177-3AD203B41FA5}">
                      <a16:colId xmlns:a16="http://schemas.microsoft.com/office/drawing/2014/main" val="738617619"/>
                    </a:ext>
                  </a:extLst>
                </a:gridCol>
                <a:gridCol w="380441">
                  <a:extLst>
                    <a:ext uri="{9D8B030D-6E8A-4147-A177-3AD203B41FA5}">
                      <a16:colId xmlns:a16="http://schemas.microsoft.com/office/drawing/2014/main" val="4209113608"/>
                    </a:ext>
                  </a:extLst>
                </a:gridCol>
                <a:gridCol w="393393">
                  <a:extLst>
                    <a:ext uri="{9D8B030D-6E8A-4147-A177-3AD203B41FA5}">
                      <a16:colId xmlns:a16="http://schemas.microsoft.com/office/drawing/2014/main" val="2790121952"/>
                    </a:ext>
                  </a:extLst>
                </a:gridCol>
                <a:gridCol w="409274">
                  <a:extLst>
                    <a:ext uri="{9D8B030D-6E8A-4147-A177-3AD203B41FA5}">
                      <a16:colId xmlns:a16="http://schemas.microsoft.com/office/drawing/2014/main" val="1797239215"/>
                    </a:ext>
                  </a:extLst>
                </a:gridCol>
                <a:gridCol w="393393">
                  <a:extLst>
                    <a:ext uri="{9D8B030D-6E8A-4147-A177-3AD203B41FA5}">
                      <a16:colId xmlns:a16="http://schemas.microsoft.com/office/drawing/2014/main" val="1557340594"/>
                    </a:ext>
                  </a:extLst>
                </a:gridCol>
                <a:gridCol w="546432">
                  <a:extLst>
                    <a:ext uri="{9D8B030D-6E8A-4147-A177-3AD203B41FA5}">
                      <a16:colId xmlns:a16="http://schemas.microsoft.com/office/drawing/2014/main" val="2949471111"/>
                    </a:ext>
                  </a:extLst>
                </a:gridCol>
              </a:tblGrid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</a:rPr>
                        <a:t>Sample I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</a:rPr>
                        <a:t>rs927753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DS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MFI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DS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MFI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Sum MFI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752648730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Sample#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P4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24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24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118218290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8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8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6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96754827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Sample#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A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11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11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360528363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A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794885225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82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7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30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831050199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P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79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79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215907026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A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149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4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14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92366361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212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1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4005750258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Sample#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00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24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25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885373525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2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P4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8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809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429201769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1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318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53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273425693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55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55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456961165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82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82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317070599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52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1522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294022060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2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2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332730484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72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172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579095674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79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79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600312987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06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06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049675971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72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72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054905844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31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160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784642511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7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7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544243410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45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45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718665332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80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30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5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56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2989449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7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7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051317682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9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9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336621482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279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7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95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760635621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0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0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37310841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05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05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545595011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5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5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078817648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0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0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681784037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6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8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5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035981459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0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790169569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6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6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205684294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5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5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31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006766363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5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5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303970004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87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87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331355359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7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7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756868127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13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13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962742527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1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71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832118170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87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87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199224560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11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11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618287454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Sample#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7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7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792897257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7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7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380472062"/>
                  </a:ext>
                </a:extLst>
              </a:tr>
              <a:tr h="1572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93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98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91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875765243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21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33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255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243901248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98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98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660164970"/>
                  </a:ext>
                </a:extLst>
              </a:tr>
              <a:tr h="1637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08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08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347009241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6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6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2934222432"/>
                  </a:ext>
                </a:extLst>
              </a:tr>
              <a:tr h="1536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mple#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P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402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402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7" marR="4347" marT="4347" marB="0" anchor="b"/>
                </a:tc>
                <a:extLst>
                  <a:ext uri="{0D108BD9-81ED-4DB2-BD59-A6C34878D82A}">
                    <a16:rowId xmlns:a16="http://schemas.microsoft.com/office/drawing/2014/main" val="147921750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FBF09F2-1168-0694-3702-83A4A095739D}"/>
              </a:ext>
            </a:extLst>
          </p:cNvPr>
          <p:cNvSpPr txBox="1"/>
          <p:nvPr/>
        </p:nvSpPr>
        <p:spPr>
          <a:xfrm>
            <a:off x="178267" y="0"/>
            <a:ext cx="609460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latin typeface="+mn-lt"/>
              </a:rPr>
              <a:t>Supplemental table 2. Anti-HLA-</a:t>
            </a:r>
            <a:r>
              <a:rPr lang="en-US" dirty="0"/>
              <a:t>DP antibodies specificity and MFI data</a:t>
            </a:r>
          </a:p>
        </p:txBody>
      </p:sp>
    </p:spTree>
    <p:extLst>
      <p:ext uri="{BB962C8B-B14F-4D97-AF65-F5344CB8AC3E}">
        <p14:creationId xmlns:p14="http://schemas.microsoft.com/office/powerpoint/2010/main" val="21450674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FDAA45D8-BA4E-41AE-83F0-2D5AF0C579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06111861"/>
              </p:ext>
            </p:extLst>
          </p:nvPr>
        </p:nvGraphicFramePr>
        <p:xfrm>
          <a:off x="3309258" y="552887"/>
          <a:ext cx="5109029" cy="802487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2558463">
                  <a:extLst>
                    <a:ext uri="{9D8B030D-6E8A-4147-A177-3AD203B41FA5}">
                      <a16:colId xmlns:a16="http://schemas.microsoft.com/office/drawing/2014/main" val="1296255167"/>
                    </a:ext>
                  </a:extLst>
                </a:gridCol>
                <a:gridCol w="2550566">
                  <a:extLst>
                    <a:ext uri="{9D8B030D-6E8A-4147-A177-3AD203B41FA5}">
                      <a16:colId xmlns:a16="http://schemas.microsoft.com/office/drawing/2014/main" val="2864247246"/>
                    </a:ext>
                  </a:extLst>
                </a:gridCol>
              </a:tblGrid>
              <a:tr h="1744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DPB1*04:01 Oligo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DPB1*05:01 Oligo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014319050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ctcaaatattctgctggc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ctcaaatattctgctggc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706585724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tcatgatgtttggggag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tcatgatgtttggggag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649924553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agcctgtgatgcactta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agcctgtgatgcactta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25807059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tgctcactaggcagaaa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tgctcactaggcagaaa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879567394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acactgagctttgtat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acactgagctttgtat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004412572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</a:rPr>
                        <a:t>ggattggacagagtctgag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attggacagagtctga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771489453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</a:rPr>
                        <a:t>gagaccatgaacccaagt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agaccatgaacccaagt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502793436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gagctcctgtttgaaa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gagctcctgtttgaaa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672792085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ggaaaagaaggactcg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ggaaaagaaggactcg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636588134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gaaacctgcagaacca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gaaacctgcagaacca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4195535806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</a:rPr>
                        <a:t>catcagtaacgccgtcag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tcagtaacgccgtcag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585808277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gtccctggaaaaggtaa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gtccctggaaaaggtaa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900747675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taaacgcgtagcattc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taaacgcgtagcattc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990298919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atctctccaggaagcgc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atctctccaggaagcgc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326852581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ttggagggggaaacatt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aaacgttcaccttaggc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4289494616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gtcaatgtcttactccg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gtcaatgtcttactccg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306558673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atgcagatcctcgttga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atgcagatcctcgttga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571092609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aaggactcatatcctcc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ggaggagcctcagtatt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758016402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ggagcctcagtgttaca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cgagagctgaggttgaa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465117248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cctgaaggctgacattg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atggagccgtgcaatgc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855692217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agccaagcaatgctctt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ctgcatcttaggctgat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465253606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tgagaggatgcgtctca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aggacaagttatcccag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487553098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agacaagttatcccagg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gcttgttctaaggcac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586491407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ttttcagtgagctcagg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tgacttcagagcaactt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435274724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cttttcctaaggcacaa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ttatgttgggttttgat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765872617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ccagatgctaacgaaac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ctactgtttactaaaacc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725169329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aagttgaaggtctgtcc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ccacattatacaatag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4168551658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ttggcagcagtatccaa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tcagaagagtgtcatg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218925296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agaaactgacttcagag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cagctcactgaaatac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060309211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catgttgggttttgatt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atgagggcactaaact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092935388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tgatgagagatgatttg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gaatagcggtctgagac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971577766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ctcttctttcctatgtt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ctgctcaccattgaata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411190058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acatatccccattttca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tcctatcaggcagatt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45977525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ggccccattatacaat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ttgaattagtgctgtgg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672990379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tcagaagagtgtcatgt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catgctctcagtaagat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95445851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cagctcactgaaatac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510639656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atgagggcactaaact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696497199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gaatagtggtctgagac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1983600229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ctgctcaccattgaata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2941678415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tcctatcaggcagatt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609449944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ttgaattagtgctgtgg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275937207"/>
                  </a:ext>
                </a:extLst>
              </a:tr>
              <a:tr h="168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catgctctcagtaaggt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45" marR="3745" marT="374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 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745" marR="3745" marT="3745" marB="0" anchor="b"/>
                </a:tc>
                <a:extLst>
                  <a:ext uri="{0D108BD9-81ED-4DB2-BD59-A6C34878D82A}">
                    <a16:rowId xmlns:a16="http://schemas.microsoft.com/office/drawing/2014/main" val="3930670484"/>
                  </a:ext>
                </a:extLst>
              </a:tr>
            </a:tbl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067708A4-497E-4A3B-A3F5-14864748DC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7629" y="-331561"/>
            <a:ext cx="10515600" cy="1325563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+mn-lt"/>
              </a:rPr>
              <a:t>Supplemental table 3. </a:t>
            </a:r>
            <a:r>
              <a:rPr lang="en-US" sz="1800" dirty="0">
                <a:latin typeface="+mn-lt"/>
                <a:ea typeface="SimSun" panose="02010600030101010101" pitchFamily="2" charset="-122"/>
              </a:rPr>
              <a:t>S</a:t>
            </a:r>
            <a:r>
              <a:rPr lang="en-US" sz="1800" dirty="0">
                <a:effectLst/>
                <a:latin typeface="+mn-lt"/>
                <a:ea typeface="SimSun" panose="02010600030101010101" pitchFamily="2" charset="-122"/>
              </a:rPr>
              <a:t>ingle stranded </a:t>
            </a:r>
            <a:r>
              <a:rPr lang="en-US" sz="1800" dirty="0" err="1">
                <a:effectLst/>
                <a:latin typeface="+mn-lt"/>
                <a:ea typeface="SimSun" panose="02010600030101010101" pitchFamily="2" charset="-122"/>
              </a:rPr>
              <a:t>exonic</a:t>
            </a:r>
            <a:r>
              <a:rPr lang="en-US" sz="1800" dirty="0">
                <a:effectLst/>
                <a:latin typeface="+mn-lt"/>
                <a:ea typeface="SimSun" panose="02010600030101010101" pitchFamily="2" charset="-122"/>
              </a:rPr>
              <a:t> oligos of DPB1*04:01 and DPB1*05:01 for FISH</a:t>
            </a:r>
            <a:endParaRPr lang="en-US" sz="18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7625611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E111C-ADFC-4D8D-AEFE-82D90D21E2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8301" y="458849"/>
            <a:ext cx="10515600" cy="621683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+mn-lt"/>
              </a:rPr>
              <a:t>Supplemental table 4. The sequences of lncRNA may potentially interact with DPB1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1F94C71C-61B3-40D6-B6E2-5844946A8C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2374944"/>
              </p:ext>
            </p:extLst>
          </p:nvPr>
        </p:nvGraphicFramePr>
        <p:xfrm>
          <a:off x="758301" y="1254125"/>
          <a:ext cx="10707985" cy="4351337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0707985">
                  <a:extLst>
                    <a:ext uri="{9D8B030D-6E8A-4147-A177-3AD203B41FA5}">
                      <a16:colId xmlns:a16="http://schemas.microsoft.com/office/drawing/2014/main" val="3271697463"/>
                    </a:ext>
                  </a:extLst>
                </a:gridCol>
              </a:tblGrid>
              <a:tr h="8288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 dirty="0">
                          <a:effectLst/>
                        </a:rPr>
                        <a:t>&gt;lnc-HLA-DPB1-13:1, Location (hg38): chr6:33029688-33030167, Strand: +, Transcript size: 383 bp </a:t>
                      </a:r>
                      <a:r>
                        <a:rPr lang="en-US" sz="1200" u="none" strike="noStrike" dirty="0">
                          <a:effectLst/>
                        </a:rPr>
                        <a:t>GCATTCAGATAAATCCTTTCCCCTGATATTTTCCCTCCATCCCCCTCCTCACAGCCCTGTTCAGAAGCCTGAACATGTCATGATGGCTGGGGCCTCAAATCCAGGGGACAATATGAGGTGAAGGTGCCAAAGCAGGAATGAAAACCTGTCCCCTCTGTTGAATACTCTTCTTCTTCACTCCTAAAACTACACACCTGATGTTAGTCGTCAGCCCTCTTCTTATCACTCTACACCTGCTGCTCTGGAGAACTCATCCAGGCCTGTGGCTCCCTGCACGTCTACACTAGTAACCTCTGAATCCACGGTCTCCAGCACTCCCTCCTGCTCCCATCCCCAGGTGGCAGTCAGGTGCCTGCACTTGGCTATCTCAACATCAACATCA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3" marR="4933" marT="4933" marB="0" anchor="ctr"/>
                </a:tc>
                <a:extLst>
                  <a:ext uri="{0D108BD9-81ED-4DB2-BD59-A6C34878D82A}">
                    <a16:rowId xmlns:a16="http://schemas.microsoft.com/office/drawing/2014/main" val="964072053"/>
                  </a:ext>
                </a:extLst>
              </a:tr>
              <a:tr h="269368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 dirty="0">
                          <a:effectLst/>
                        </a:rPr>
                        <a:t>&gt;lnc-HLA-DPB1-13:2, Location (hg38): chr6:33029688-33031118, Strand: +, Transcript size: 1431 bp </a:t>
                      </a:r>
                      <a:r>
                        <a:rPr lang="en-US" sz="1200" u="none" strike="noStrike" dirty="0">
                          <a:effectLst/>
                        </a:rPr>
                        <a:t>GCATTCAGATAAATCCTTTCCCCTGATATTTTCCCTCCATCCCCCTCCTCACAGCCCTGTTCAGAAGCCTGAACATGTCATGATGGCTGGGGCCTCAAATCCAGGGGACAATATGAGGTGAAGGTGAGCAAGGAGACAGTCTACAAAGAGGCCGTGGAAGCTGTCGGGGAAGGAGAATGTTCAAGTAGCACAGGCAATCAAACACTTCCTATTGCTCCAGGTGCCAAAGCAGGAATGAAAACCTGTCCCCTCTGTTGAATACTCTTCTTCTTCACTCCTAAAACTACACACCTGATGTTAGTCGTCAGCCCTCTTCTTATCACTCTACACCTGCTGCTCTGGAGAACTCATCCAGGCCTGTGGCTCCCTGCACGTCTACACTAGTAACCTCTGAATCCACGGTCTCCAGCACTCCCTCCTGCTCCCATCCCCAGGTGGCAGTCAGGTGCCTGCACTTGGCTATCTCAACATCAACATCACCCCAACACCTGTTTTTTCATGCATTCAAGGGAGATTTTTTTTCTCCCCAAGTTTCTTTCACCTTCCCTTTGGGGTTCCTGGAATAAATAATACAAAACTTGAGGTTCTCTTGTGATGCTGTTTGGAGTCGAGAGAGAGACAGAGAGAGAGAGATACCCCCAGGAGGGAGTTGTCCCGATTCTTTTCCATCACTCGGGAGCTAGCCCTACATCTAGTCTTACTGTTTGGAGCCTTATAAAAAGATCTCATGAGCAGCCCCCTGGGAATAGCATGTCTTTGTTCTCTGAGAGGCAATGATTTTTATCTGGACCCCACATAACTTTTCCCCAGAGAGCATCACAGTAAAAGCACATGTTTATCTTCTCTCCTTAACTTCTGACATCCTTAAATCCCAAGGAAGGGTATGGAGGGAGACAGATTGATGATTCTGTGTATTTGGGTAAACCAGGTTCCTGGCTAAAATCACTTAGTCAAAAATGCCAAGCATGGTCAAGGGAGAAGGGTTAGAGAGTCTAAAAGAATGAAATTTGGAGACAGGTAAACTTGAAATTTATTCTTTCCTTCACCTATTATTGTGTATGTGATTTGGGGTCATATTCTTAACTATAACTACCTATTGCCTCATCTTAGAATAAGGATAAATAATATCTATGTTGAAACACTGCTGTGAGCATTAGTGCTCAATAACTATTACTACTGTACTAATGCAGGTTCTTGATTTTAAACAATAGAATGCAAACTTGAATAATTAAGCAGAAAAGGCATTTATTGGAAAGGAACTAAATAGCTCATAGAGGATATGACAAAGGCAGGAGTTCTTCATAGTTGATATTGTATCTCCGTGCATTGAATCAGGAGACACATGATGTTGATTTGTTCTGTTATCAGTGATGCTAATTTTGACTACTTGATTTTAGTGGTAACTGACAGATTTTTTCAACCATAAAGTT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3" marR="4933" marT="4933" marB="0" anchor="ctr"/>
                </a:tc>
                <a:extLst>
                  <a:ext uri="{0D108BD9-81ED-4DB2-BD59-A6C34878D82A}">
                    <a16:rowId xmlns:a16="http://schemas.microsoft.com/office/drawing/2014/main" val="514529803"/>
                  </a:ext>
                </a:extLst>
              </a:tr>
              <a:tr h="8288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 dirty="0">
                          <a:effectLst/>
                        </a:rPr>
                        <a:t>&gt;lnc-HLA-DPB1-14:1, Location (hg38): chr6:32970232-32970886, Strand: +, Transcript size: 338 bp </a:t>
                      </a:r>
                      <a:r>
                        <a:rPr lang="en-US" sz="1200" u="none" strike="noStrike" dirty="0">
                          <a:effectLst/>
                        </a:rPr>
                        <a:t>AAAGTTGCTGTGTCATTGCCCTCCATGCTGCAGCCACCCAAACGGGGCCGCTTGTACTTTTGGGGGCCAGGGCCTGATCCCTGGCTGGGGGAAGGGGACTCTGCTCTCCTGACGCTCATTTTCCCCCGCCCTCCCGGGGTTTGCCCTACTCGGGGGGTCAGAAGACAGGAGATTGGCGGCCATTTTAGACGCAGTAACCGAGAGTCTGCACCCTTATTTAGATAACCAAGTTAGGAGGAAGACTTAAGAGTAAGTTGGGGGGAGGGGGCGAAACTGAGCTCCCAAAATGGCTCCTGCCCCTCCTCGGAGGCGGACGGCCGGGGGGAGGGGAGGAGGGG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3" marR="4933" marT="4933" marB="0" anchor="ctr"/>
                </a:tc>
                <a:extLst>
                  <a:ext uri="{0D108BD9-81ED-4DB2-BD59-A6C34878D82A}">
                    <a16:rowId xmlns:a16="http://schemas.microsoft.com/office/drawing/2014/main" val="10872933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53373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47</TotalTime>
  <Words>771</Words>
  <Application>Microsoft Office PowerPoint</Application>
  <PresentationFormat>Widescreen</PresentationFormat>
  <Paragraphs>53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1_Office Theme</vt:lpstr>
      <vt:lpstr>Supplementary Material</vt:lpstr>
      <vt:lpstr>PowerPoint Presentation</vt:lpstr>
      <vt:lpstr>PowerPoint Presentation</vt:lpstr>
      <vt:lpstr>PowerPoint Presentation</vt:lpstr>
      <vt:lpstr>Supplemental table 3. Single stranded exonic oligos of DPB1*04:01 and DPB1*05:01 for FISH</vt:lpstr>
      <vt:lpstr>Supplemental table 4. The sequences of lncRNA may potentially interact with DPB1</vt:lpstr>
    </vt:vector>
  </TitlesOfParts>
  <Company>UCLA Health Scien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, Yuxin</dc:creator>
  <cp:lastModifiedBy>Yin, Yuxin</cp:lastModifiedBy>
  <cp:revision>230</cp:revision>
  <cp:lastPrinted>2023-07-10T16:45:30Z</cp:lastPrinted>
  <dcterms:created xsi:type="dcterms:W3CDTF">2023-03-15T21:46:21Z</dcterms:created>
  <dcterms:modified xsi:type="dcterms:W3CDTF">2024-01-06T05:14:21Z</dcterms:modified>
</cp:coreProperties>
</file>